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102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51055A-B5BF-364B-3569-8E21CDAC39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F9603E-844E-2042-DEBD-CE93C1BCF3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20C96C-A513-48F3-92FC-9E710546B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9BEA65-8D6C-20C0-9397-B27440287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27E237-B1A7-1556-4048-8B5913D97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381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44A99A-C58B-0A84-628B-4819954CCD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078165-5575-63F5-5CC1-121FA34387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226B89-444C-97D8-4035-BFB268D3C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4C144B-7D5F-2413-CC61-A98C6074C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8F68CE-DFFA-EA22-4524-ACEDEC506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848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00D9702-C4CA-CB42-9982-8985430239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0CDD8D-6CA2-52DD-475C-10D8631E64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E14087-54E6-C8E3-05E7-1CA55E18C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D3FDA-BDB9-9925-93EB-7CC9AF3E9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A32BA8-1EBD-BEBA-5C2D-5E1671604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466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4C252F-58AD-715B-D478-9D8CDAB419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789558-F74B-7FC0-AFA5-A8FC0261B5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EB4147-8084-4428-5994-1CFC10131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DBB13F-8A21-4157-7A89-5BE0B98B9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D702C9-575A-3631-5409-6857BDBB3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6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7AC402-6451-42F8-21C1-D510622E3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A3F873-90D6-7B06-965E-4980B95800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823951-1D6D-9C3B-4BA3-5B564D17A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160D8B-3BB2-DE59-0F6C-2D41EF68D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65633-D976-F022-66DA-3C88926F8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064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1CD82D-7E6A-B857-0640-116A21821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1F10DF-B1BD-5B9E-17AF-2D0E28B192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F69FF3-FC90-0BAF-D3B7-5B036D6A1F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DBA81E-40A9-6732-5D48-E39BDC260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37C2E3-7528-6802-70D9-0CE867C99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741C93-7A65-16CA-3CD1-9FE511ED0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256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EF9BEB-BECD-98B9-B5E3-9F3D858063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69CAC1-558C-977E-58AA-0133B6E338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738108-9062-2D3F-0787-FFBF137FB6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F54709-4477-0596-5EE0-DD6E88E561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E61816-B7DA-B76D-74CD-0202DF2F56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FE8253-D19B-6556-39AE-80183640F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F09DF62-E8DC-41CE-725B-605F5FFCD1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5BA814-3F53-4147-77C7-69ADDD2D5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527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ABFE13-0116-88DB-A75A-CB4ADA132A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4CB43B-49E3-C341-6CF8-2C6B53829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B9ECD3-316C-221E-EB1E-2CBA0ADE1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24558B3-A961-1151-6BC2-ABD153AF9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10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6E5D4A-8677-77DF-DD7F-661FB628C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D2BEBE-3B22-76C3-2F3D-50B4A7D18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4B71C9-7788-3DB4-FA23-614F4962F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7534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084B9F-DB0E-6C9F-E45D-A8E4CC7867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766320-EFEF-1A07-BF36-702A7A43CA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902241-D7AA-4763-CE6E-C2C0D909A2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335DBE-F83A-1531-C8A5-51554A211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68D810-0DA1-C5FD-92D8-503C22950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4BBF2E-0970-B932-6F8D-6B8E177A4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828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E32918-22BB-304E-E6E4-BDC9600E4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88ED0E-FC80-C62C-0E23-EA3CE84F9C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F01D4-F9A5-0346-64AE-8F41B868DB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70CC81-8E39-BB6D-C0F2-FDE36A855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061DCC-48B2-FB2A-9848-A45839FCF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AEFFEA-9CDF-3CD8-326B-CD84D3AFF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202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8B015B-DA04-6654-0983-B8908BA8A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036D41-CC27-8042-6F76-088A20143B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75B113-D0C0-C512-3694-E3801E37C1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C52B1-EBCC-4FA2-B0DE-717C93A0F2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7665E0-E13A-893B-A98C-F38B19DCAC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2BF47A-4F85-995A-7C7B-E590508E3D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20B3B-36E4-4DA4-9B14-65EA67E93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111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B13CE54-D668-B5C2-5975-538F1A497A2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121" t="2669" r="10652" b="3684"/>
          <a:stretch/>
        </p:blipFill>
        <p:spPr>
          <a:xfrm rot="5400000">
            <a:off x="3457543" y="-1469274"/>
            <a:ext cx="6048442" cy="928687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F25BA63-EB83-75A9-757C-3645A790967B}"/>
              </a:ext>
            </a:extLst>
          </p:cNvPr>
          <p:cNvSpPr txBox="1"/>
          <p:nvPr/>
        </p:nvSpPr>
        <p:spPr>
          <a:xfrm>
            <a:off x="2000250" y="6338724"/>
            <a:ext cx="96202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Figure S1: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 (Phytol)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33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3E04282-3FC3-667A-5098-38A266E509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6138" y="741136"/>
            <a:ext cx="5364982" cy="393895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3700C1B-5A29-A878-DE78-D1A60747F4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4024023" y="2495275"/>
            <a:ext cx="4143953" cy="133368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E6FCB7E-652C-2EED-E7D0-459C033EAC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4876260" y="2724075"/>
            <a:ext cx="6563641" cy="11717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62BA37F-003F-A32A-0BA4-AE16F9F9819C}"/>
              </a:ext>
            </a:extLst>
          </p:cNvPr>
          <p:cNvSpPr txBox="1"/>
          <p:nvPr/>
        </p:nvSpPr>
        <p:spPr>
          <a:xfrm>
            <a:off x="1838325" y="6407099"/>
            <a:ext cx="96202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Figure S2: Partially </a:t>
            </a:r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Expanded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 (Phytol)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73619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9B70DA3-D902-DF95-5506-DA6C18ADFB4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076" r="9812"/>
          <a:stretch/>
        </p:blipFill>
        <p:spPr>
          <a:xfrm rot="5400000">
            <a:off x="4979456" y="-1497546"/>
            <a:ext cx="5507906" cy="924103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4551DAC-05CB-6D8D-0FDD-E72A4D55A9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-665391" y="1208316"/>
            <a:ext cx="4415096" cy="295096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7871694-15CB-BB15-B299-46B6646048AF}"/>
              </a:ext>
            </a:extLst>
          </p:cNvPr>
          <p:cNvSpPr txBox="1"/>
          <p:nvPr/>
        </p:nvSpPr>
        <p:spPr>
          <a:xfrm>
            <a:off x="2486026" y="6254234"/>
            <a:ext cx="76295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Figure S3: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C NMR spectrum (1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 (Phytol)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32506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034E534-B98A-7908-6604-A20A881F22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8216"/>
          <a:stretch/>
        </p:blipFill>
        <p:spPr>
          <a:xfrm rot="5400000">
            <a:off x="4825404" y="-1327747"/>
            <a:ext cx="5962650" cy="861814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02B5DAD-A497-D0B6-BA5D-7F076942E0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-896365" y="1427582"/>
            <a:ext cx="4991100" cy="270743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18D4A41-F13D-956F-BB36-94AA94F97080}"/>
              </a:ext>
            </a:extLst>
          </p:cNvPr>
          <p:cNvSpPr txBox="1"/>
          <p:nvPr/>
        </p:nvSpPr>
        <p:spPr>
          <a:xfrm>
            <a:off x="1838325" y="6446469"/>
            <a:ext cx="97726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cs typeface="Vrinda" panose="020B0502040204020203" pitchFamily="34" charset="0"/>
              </a:rPr>
              <a:t>Figure S4: Partially </a:t>
            </a:r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Expanded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2 (Lupeol)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31928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3483B3C-ED9A-7350-B1ED-2B453003B8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4859021" y="-695712"/>
            <a:ext cx="5617210" cy="781050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C68026A-1C98-472B-7B96-0E7139AA26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-1431665" y="1712248"/>
            <a:ext cx="5034924" cy="177175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CF4A7AB-EC7A-762F-254D-41A87E4F6B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188550" y="2454337"/>
            <a:ext cx="5617212" cy="86986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3A2E785-EBD4-95E3-5539-E996D63CC0DD}"/>
              </a:ext>
            </a:extLst>
          </p:cNvPr>
          <p:cNvSpPr txBox="1"/>
          <p:nvPr/>
        </p:nvSpPr>
        <p:spPr>
          <a:xfrm>
            <a:off x="1419227" y="6397596"/>
            <a:ext cx="101536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cs typeface="Vrinda" panose="020B0502040204020203" pitchFamily="34" charset="0"/>
              </a:rPr>
              <a:t>Figure S5: Partially </a:t>
            </a:r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Expanded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3 (Stigmasterol)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10586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1E0AB3E-512B-D8A0-2231-53EB8A3DDC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4900381" y="-1373055"/>
            <a:ext cx="5686888" cy="8686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0DC31BE-2451-F255-339A-DA626C14D4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-1412598" y="2003147"/>
            <a:ext cx="5611344" cy="160504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30DD171-FF72-AB05-C224-F1FC1A1A2A56}"/>
              </a:ext>
            </a:extLst>
          </p:cNvPr>
          <p:cNvSpPr txBox="1"/>
          <p:nvPr/>
        </p:nvSpPr>
        <p:spPr>
          <a:xfrm>
            <a:off x="1219202" y="6361767"/>
            <a:ext cx="1047749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cs typeface="Vrinda" panose="020B0502040204020203" pitchFamily="34" charset="0"/>
              </a:rPr>
              <a:t>Figure S6: Partially </a:t>
            </a:r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Expanded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4 (</a:t>
            </a:r>
            <a:r>
              <a:rPr lang="en-SG" sz="18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Friedelanol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 Acetate)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52328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A4C859B-416F-92FF-CD3B-5E49043418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4646660" y="-1517912"/>
            <a:ext cx="5794280" cy="90487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3A5E414-734D-A775-A219-DDDB39EE6F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-872127" y="1810048"/>
            <a:ext cx="4811406" cy="169555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58DB4AF-353F-0EC7-D8E5-84535E7B0CA4}"/>
              </a:ext>
            </a:extLst>
          </p:cNvPr>
          <p:cNvSpPr txBox="1"/>
          <p:nvPr/>
        </p:nvSpPr>
        <p:spPr>
          <a:xfrm>
            <a:off x="857251" y="6236547"/>
            <a:ext cx="104774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cs typeface="Vrinda" panose="020B0502040204020203" pitchFamily="34" charset="0"/>
              </a:rPr>
              <a:t>Figure S7: Partially </a:t>
            </a:r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Expanded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5 (</a:t>
            </a:r>
            <a:r>
              <a:rPr lang="el-GR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β</a:t>
            </a:r>
            <a:r>
              <a:rPr lang="en-GB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-Amyrin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1252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647EF6D-7796-238F-84AA-E5C4D14A46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4582236" y="1366566"/>
            <a:ext cx="5372850" cy="389626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1FFF0A0-945C-7F2E-D4A1-593FF16B68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508493" y="1910480"/>
            <a:ext cx="6173303" cy="265639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FD20523-0684-C748-514D-9EBB6C2B4F1F}"/>
              </a:ext>
            </a:extLst>
          </p:cNvPr>
          <p:cNvSpPr txBox="1"/>
          <p:nvPr/>
        </p:nvSpPr>
        <p:spPr>
          <a:xfrm>
            <a:off x="857251" y="6337019"/>
            <a:ext cx="104774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b="1">
                <a:solidFill>
                  <a:srgbClr val="000000"/>
                </a:solidFill>
                <a:latin typeface="Times New Roman" panose="02020603050405020304" pitchFamily="18" charset="0"/>
                <a:cs typeface="Vrinda" panose="020B0502040204020203" pitchFamily="34" charset="0"/>
              </a:rPr>
              <a:t>Figure S8</a:t>
            </a:r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cs typeface="Vrinda" panose="020B0502040204020203" pitchFamily="34" charset="0"/>
              </a:rPr>
              <a:t>: Partially </a:t>
            </a:r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Expanded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6 (</a:t>
            </a:r>
            <a:r>
              <a:rPr lang="el-GR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β</a:t>
            </a:r>
            <a:r>
              <a:rPr lang="en-GB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-Sitosterol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7294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159</Words>
  <Application>Microsoft Office PowerPoint</Application>
  <PresentationFormat>Widescreen</PresentationFormat>
  <Paragraphs>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rial</vt:lpstr>
      <vt:lpstr>Calibri</vt:lpstr>
      <vt:lpstr>Calibri Light</vt:lpstr>
      <vt:lpstr>Palatino Linotype</vt:lpstr>
      <vt:lpstr>Times New Roman</vt:lpstr>
      <vt:lpstr>Vrind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ia Ashrafi</dc:creator>
  <cp:lastModifiedBy>MDPI</cp:lastModifiedBy>
  <cp:revision>17</cp:revision>
  <dcterms:created xsi:type="dcterms:W3CDTF">2023-02-22T06:57:46Z</dcterms:created>
  <dcterms:modified xsi:type="dcterms:W3CDTF">2023-05-19T03:14:41Z</dcterms:modified>
</cp:coreProperties>
</file>